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7023100" cy="93091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2" d="100"/>
          <a:sy n="62" d="100"/>
        </p:scale>
        <p:origin x="1330" y="5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ー サブタイトルの書式設定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86508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86370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60196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84875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35178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29625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48152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7317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49511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9150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87368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3734A1-549B-46EE-AAE4-7289B03A47E7}" type="datetimeFigureOut">
              <a:rPr lang="en-US" smtClean="0"/>
              <a:t>4/22/2016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902E20-B9F7-42EA-BB8A-2A52F25001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67106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/>
          <p:cNvSpPr txBox="1"/>
          <p:nvPr/>
        </p:nvSpPr>
        <p:spPr>
          <a:xfrm>
            <a:off x="395536" y="1124744"/>
            <a:ext cx="340189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able EV 1. </a:t>
            </a:r>
          </a:p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icroscope and lens information</a:t>
            </a:r>
          </a:p>
        </p:txBody>
      </p:sp>
      <p:graphicFrame>
        <p:nvGraphicFramePr>
          <p:cNvPr id="3" name="表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01589281"/>
              </p:ext>
            </p:extLst>
          </p:nvPr>
        </p:nvGraphicFramePr>
        <p:xfrm>
          <a:off x="446857" y="1844824"/>
          <a:ext cx="8229599" cy="3146460"/>
        </p:xfrm>
        <a:graphic>
          <a:graphicData uri="http://schemas.openxmlformats.org/drawingml/2006/table">
            <a:tbl>
              <a:tblPr/>
              <a:tblGrid>
                <a:gridCol w="1143318"/>
                <a:gridCol w="1181625"/>
                <a:gridCol w="1274074"/>
                <a:gridCol w="2888383"/>
                <a:gridCol w="1742199"/>
              </a:tblGrid>
              <a:tr h="163331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mage location </a:t>
                      </a:r>
                    </a:p>
                  </a:txBody>
                  <a:tcPr marL="8596" marR="8596" marT="859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icroscope </a:t>
                      </a:r>
                    </a:p>
                  </a:txBody>
                  <a:tcPr marL="8596" marR="8596" marT="859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ens </a:t>
                      </a:r>
                    </a:p>
                  </a:txBody>
                  <a:tcPr marL="8596" marR="8596" marT="859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amera </a:t>
                      </a:r>
                    </a:p>
                  </a:txBody>
                  <a:tcPr marL="8596" marR="8596" marT="859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333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igure 2A  </a:t>
                      </a:r>
                    </a:p>
                  </a:txBody>
                  <a:tcPr marL="8596" marR="8596" marT="859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596" marR="8596" marT="859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X41 (Olympus) </a:t>
                      </a:r>
                    </a:p>
                  </a:txBody>
                  <a:tcPr marL="8596" marR="8596" marT="859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UPlan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1 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0x NA/0.5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596" marR="8596" marT="859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Olympus America KIH03678</a:t>
                      </a:r>
                    </a:p>
                  </a:txBody>
                  <a:tcPr marL="8596" marR="8596" marT="859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3331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igure 2B</a:t>
                      </a:r>
                    </a:p>
                  </a:txBody>
                  <a:tcPr marL="8596" marR="8596" marT="859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eft and middle </a:t>
                      </a:r>
                    </a:p>
                  </a:txBody>
                  <a:tcPr marL="8596" marR="8596" marT="859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SM710 (Zeiss) </a:t>
                      </a:r>
                    </a:p>
                  </a:txBody>
                  <a:tcPr marL="8596" marR="8596" marT="859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lan-Apochromat 10x NA/ 0.45 </a:t>
                      </a:r>
                    </a:p>
                  </a:txBody>
                  <a:tcPr marL="8596" marR="8596" marT="859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596" marR="8596" marT="859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333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ight </a:t>
                      </a:r>
                    </a:p>
                  </a:txBody>
                  <a:tcPr marL="8596" marR="8596" marT="859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lan-Apochromat 20x NA/ 0.8 </a:t>
                      </a:r>
                    </a:p>
                  </a:txBody>
                  <a:tcPr marL="8596" marR="8596" marT="859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596" marR="8596" marT="859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333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igure 2C and 2D </a:t>
                      </a:r>
                    </a:p>
                  </a:txBody>
                  <a:tcPr marL="8596" marR="8596" marT="859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596" marR="8596" marT="859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SM710 (Zeiss) </a:t>
                      </a:r>
                    </a:p>
                  </a:txBody>
                  <a:tcPr marL="8596" marR="8596" marT="859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lan-Apochromat 100x NA/ 1.40 Oil DIC</a:t>
                      </a:r>
                    </a:p>
                  </a:txBody>
                  <a:tcPr marL="8596" marR="8596" marT="859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596" marR="8596" marT="859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3331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igure 4C </a:t>
                      </a:r>
                    </a:p>
                  </a:txBody>
                  <a:tcPr marL="8596" marR="8596" marT="859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eft </a:t>
                      </a:r>
                    </a:p>
                  </a:txBody>
                  <a:tcPr marL="8596" marR="8596" marT="859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Z-9000 (Keyence)  </a:t>
                      </a:r>
                    </a:p>
                  </a:txBody>
                  <a:tcPr marL="8596" marR="8596" marT="859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FI Plan Apo 10x NA/ 0.45 </a:t>
                      </a:r>
                    </a:p>
                  </a:txBody>
                  <a:tcPr marL="8596" marR="8596" marT="859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ll-in one microscope </a:t>
                      </a:r>
                    </a:p>
                  </a:txBody>
                  <a:tcPr marL="8596" marR="8596" marT="859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333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ight </a:t>
                      </a:r>
                    </a:p>
                  </a:txBody>
                  <a:tcPr marL="8596" marR="8596" marT="859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FI Plan Apo 20x NA/ 0.75 </a:t>
                      </a:r>
                    </a:p>
                  </a:txBody>
                  <a:tcPr marL="8596" marR="8596" marT="859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63331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igure 5C </a:t>
                      </a:r>
                    </a:p>
                  </a:txBody>
                  <a:tcPr marL="8596" marR="8596" marT="859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op </a:t>
                      </a:r>
                    </a:p>
                  </a:txBody>
                  <a:tcPr marL="8596" marR="8596" marT="859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Z-9000 (Keyence)  </a:t>
                      </a:r>
                    </a:p>
                  </a:txBody>
                  <a:tcPr marL="8596" marR="8596" marT="859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FI Plan Apo 10x NA/ 0.45 </a:t>
                      </a:r>
                    </a:p>
                  </a:txBody>
                  <a:tcPr marL="8596" marR="8596" marT="859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6333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iddle </a:t>
                      </a:r>
                    </a:p>
                  </a:txBody>
                  <a:tcPr marL="8596" marR="8596" marT="859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FI Plan Apo 20x NA/ 0.75 </a:t>
                      </a:r>
                    </a:p>
                  </a:txBody>
                  <a:tcPr marL="8596" marR="8596" marT="859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6333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ottom </a:t>
                      </a:r>
                    </a:p>
                  </a:txBody>
                  <a:tcPr marL="8596" marR="8596" marT="859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FI Plan Apo </a:t>
                      </a:r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λ60</a:t>
                      </a: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x H NA/ 1.40 Oil  </a:t>
                      </a:r>
                    </a:p>
                  </a:txBody>
                  <a:tcPr marL="8596" marR="8596" marT="859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71928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igure 5D</a:t>
                      </a:r>
                    </a:p>
                  </a:txBody>
                  <a:tcPr marL="8596" marR="8596" marT="859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op </a:t>
                      </a:r>
                    </a:p>
                  </a:txBody>
                  <a:tcPr marL="8596" marR="8596" marT="859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X40 (Olympus)</a:t>
                      </a:r>
                    </a:p>
                  </a:txBody>
                  <a:tcPr marL="8596" marR="8596" marT="859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UApo 340 20x NA/ 0.75 </a:t>
                      </a:r>
                    </a:p>
                  </a:txBody>
                  <a:tcPr marL="8596" marR="8596" marT="859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Olympus U-TUI</a:t>
                      </a:r>
                    </a:p>
                  </a:txBody>
                  <a:tcPr marL="8596" marR="8596" marT="859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333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iddle and 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ottom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596" marR="8596" marT="859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UApo 340 20x NA/ 0.75, </a:t>
                      </a:r>
                      <a:endParaRPr lang="en-US" sz="11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  <a:p>
                      <a:pPr algn="ctr" fontAlgn="b"/>
                      <a:r>
                        <a:rPr lang="pl-PL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U-POT drop </a:t>
                      </a:r>
                      <a:r>
                        <a:rPr lang="pl-PL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n polarizer  </a:t>
                      </a:r>
                    </a:p>
                  </a:txBody>
                  <a:tcPr marL="8596" marR="8596" marT="859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6333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igure 6A</a:t>
                      </a:r>
                    </a:p>
                  </a:txBody>
                  <a:tcPr marL="8596" marR="8596" marT="859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596" marR="8596" marT="859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Z-9000 (Keyence)  </a:t>
                      </a:r>
                    </a:p>
                  </a:txBody>
                  <a:tcPr marL="8596" marR="8596" marT="859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FI Plan Apo 20x NA/ 0.75 </a:t>
                      </a:r>
                    </a:p>
                  </a:txBody>
                  <a:tcPr marL="8596" marR="8596" marT="859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ll-in one microscope </a:t>
                      </a:r>
                    </a:p>
                  </a:txBody>
                  <a:tcPr marL="8596" marR="8596" marT="859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333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igure 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596" marR="8596" marT="859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596" marR="8596" marT="859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Z-9000 (Keyence)  </a:t>
                      </a:r>
                    </a:p>
                  </a:txBody>
                  <a:tcPr marL="8596" marR="8596" marT="859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hase Lens, S PL FL ELWD ADM 20x C NA/ 0.45</a:t>
                      </a:r>
                    </a:p>
                  </a:txBody>
                  <a:tcPr marL="8596" marR="8596" marT="859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6333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igure 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596" marR="8596" marT="859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596" marR="8596" marT="859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Z-9000 (Keyence)  </a:t>
                      </a:r>
                    </a:p>
                  </a:txBody>
                  <a:tcPr marL="8596" marR="8596" marT="859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FI Plan Apo 40x NA/ 0.95 </a:t>
                      </a:r>
                    </a:p>
                  </a:txBody>
                  <a:tcPr marL="8596" marR="8596" marT="859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855963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26</TotalTime>
  <Words>196</Words>
  <Application>Microsoft Office PowerPoint</Application>
  <PresentationFormat>On-screen Show (4:3)</PresentationFormat>
  <Paragraphs>6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ＭＳ Ｐゴシック</vt:lpstr>
      <vt:lpstr>Arial</vt:lpstr>
      <vt:lpstr>Calibri</vt:lpstr>
      <vt:lpstr>Office ​​テーマ</vt:lpstr>
      <vt:lpstr>PowerPoint Presentation</vt:lpstr>
    </vt:vector>
  </TitlesOfParts>
  <Company>bu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onomi</dc:creator>
  <cp:lastModifiedBy>Whittaker, Linda D</cp:lastModifiedBy>
  <cp:revision>55</cp:revision>
  <cp:lastPrinted>2015-12-11T18:55:13Z</cp:lastPrinted>
  <dcterms:created xsi:type="dcterms:W3CDTF">2015-07-06T18:02:00Z</dcterms:created>
  <dcterms:modified xsi:type="dcterms:W3CDTF">2016-04-22T13:29:00Z</dcterms:modified>
</cp:coreProperties>
</file>